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>
        <p:scale>
          <a:sx n="100" d="100"/>
          <a:sy n="100" d="100"/>
        </p:scale>
        <p:origin x="25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350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675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5349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5356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1839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228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31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8791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2623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950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5036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03273-B9A2-426C-8722-46488A8217E5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BA895-3546-43CC-BBB3-E0D4D5112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6642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5D5C9A8E-EE85-427A-86DD-AB392C1EC0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12" y="1538287"/>
            <a:ext cx="5819775" cy="581977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1CEBE4D-69D4-4C9A-BF92-CBC09A886C9A}"/>
              </a:ext>
            </a:extLst>
          </p:cNvPr>
          <p:cNvSpPr txBox="1"/>
          <p:nvPr/>
        </p:nvSpPr>
        <p:spPr>
          <a:xfrm>
            <a:off x="581024" y="966787"/>
            <a:ext cx="566737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bdominal cryptorchidism genome-wide association study using the software package GEMMA of 778 cases versus 778 controls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586582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</TotalTime>
  <Words>1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ades, Matthew</dc:creator>
  <cp:lastModifiedBy>Forman, Oliver</cp:lastModifiedBy>
  <cp:revision>9</cp:revision>
  <dcterms:created xsi:type="dcterms:W3CDTF">2021-09-22T14:44:30Z</dcterms:created>
  <dcterms:modified xsi:type="dcterms:W3CDTF">2022-03-22T12:41:27Z</dcterms:modified>
</cp:coreProperties>
</file>